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8"/>
  </p:notesMasterIdLst>
  <p:sldIdLst>
    <p:sldId id="261" r:id="rId2"/>
    <p:sldId id="265" r:id="rId3"/>
    <p:sldId id="272" r:id="rId4"/>
    <p:sldId id="285" r:id="rId5"/>
    <p:sldId id="281" r:id="rId6"/>
    <p:sldId id="284" r:id="rId7"/>
  </p:sldIdLst>
  <p:sldSz cx="9144000" cy="5143500" type="screen16x9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077"/>
    <p:restoredTop sz="75816"/>
  </p:normalViewPr>
  <p:slideViewPr>
    <p:cSldViewPr snapToGrid="0">
      <p:cViewPr varScale="1">
        <p:scale>
          <a:sx n="110" d="100"/>
          <a:sy n="110" d="100"/>
        </p:scale>
        <p:origin x="1768" y="168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Google Shape;86;geb42ef6ec3_0_2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7" name="Google Shape;87;geb42ef6ec3_0_2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MTEQDQRLKQFDEKLAELEKTIKQVQEQRREYINRKGLNK</a:t>
            </a:r>
            <a:endParaRPr dirty="0"/>
          </a:p>
          <a:p>
            <a:pPr marL="457200" lvl="0" indent="-298450" algn="l" rtl="0">
              <a:spcBef>
                <a:spcPts val="0"/>
              </a:spcBef>
              <a:spcAft>
                <a:spcPts val="0"/>
              </a:spcAft>
              <a:buSzPts val="1100"/>
              <a:buChar char="●"/>
            </a:pPr>
            <a:r>
              <a:rPr lang="en" dirty="0"/>
              <a:t>Appears in another genome not displayed here: MK685667.1_Klebsiella_phage_vB_KpnM_IME346</a:t>
            </a:r>
            <a:endParaRPr dirty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Google Shape;117;geb42ef6ec3_0_6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8" name="Google Shape;118;geb42ef6ec3_0_6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MAKVIIEIKNTVSGIKGRNLRTSIAVDGSAELDGDEGTLAGMVALLVLNKSQKIINESAHEAIEILKNDGVITSGRVTEMAVEKTCH</a:t>
            </a:r>
            <a:endParaRPr dirty="0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Google Shape;169;geb42ef6ec3_0_13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70" name="Google Shape;170;geb42ef6ec3_0_13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MNYALYQYINRDGVVAHALVNTKTKDVMLADTVIYFERGNLVWKPAAHPEYVWLAIQNDKHHKIVAMATHPHFIKARG</a:t>
            </a:r>
            <a:endParaRPr dirty="0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58750" indent="0">
              <a:buNone/>
            </a:pPr>
            <a:r>
              <a:rPr lang="en-US" dirty="0"/>
              <a:t>MRRLNITPAEMESVCGRMVACRAAEHLGLNINQFYYIAKKLSLKTAFVKPRWSDDEDKRMQTLISSGYTQRNVAKILGRSEESVKSRLSRLRKK</a:t>
            </a:r>
          </a:p>
        </p:txBody>
      </p:sp>
    </p:spTree>
    <p:extLst>
      <p:ext uri="{BB962C8B-B14F-4D97-AF65-F5344CB8AC3E}">
        <p14:creationId xmlns:p14="http://schemas.microsoft.com/office/powerpoint/2010/main" val="384874798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Google Shape;240;geb42ef6ec3_0_23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41" name="Google Shape;241;geb42ef6ec3_0_23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MTIDYRRTYFFDTKRKVNNIISGIASLDIMIYAIQGKAGKEVLAEILSERNIAIPPTLRCLTPEELKALAFVVCKSQLKTTTVGGRMKVVLRVLLLITH</a:t>
            </a:r>
            <a:endParaRPr dirty="0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1" name="Google Shape;261;geb42ef6ec3_0_26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62" name="Google Shape;262;geb42ef6ec3_0_26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MINAKEELLLALKNTNSEVKCIKIEFGYYGDKEVWVLPVGYTEKDIEDFLDNLDFKYDSGFGGQLLYGNVWFTDGTWLERGEYDGSEWWEYKTTPAIPEECRTINGEVDRTLLLN</a:t>
            </a: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sv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sv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sv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sv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phic 4">
            <a:extLst>
              <a:ext uri="{FF2B5EF4-FFF2-40B4-BE49-F238E27FC236}">
                <a16:creationId xmlns:a16="http://schemas.microsoft.com/office/drawing/2014/main" id="{F4D3F548-6537-6D7A-72BD-4B43FEC0C4C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 r="5689"/>
          <a:stretch/>
        </p:blipFill>
        <p:spPr>
          <a:xfrm>
            <a:off x="-197509" y="2044079"/>
            <a:ext cx="9210948" cy="2577042"/>
          </a:xfrm>
          <a:prstGeom prst="rect">
            <a:avLst/>
          </a:prstGeom>
        </p:spPr>
      </p:pic>
      <p:sp>
        <p:nvSpPr>
          <p:cNvPr id="89" name="Google Shape;89;p18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720" dirty="0"/>
              <a:t>UDP0048__ATI16509.1_in_MF663761.1</a:t>
            </a:r>
            <a:endParaRPr sz="172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720" dirty="0"/>
              <a:t>Klebsiella_phage_vB_KpnM_KpV79_at_36068..35946_desc:hypothetical-protein</a:t>
            </a:r>
            <a:endParaRPr sz="172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720" dirty="0"/>
              <a:t>0.830phamily36007</a:t>
            </a:r>
            <a:endParaRPr sz="1720" dirty="0"/>
          </a:p>
        </p:txBody>
      </p:sp>
      <p:sp>
        <p:nvSpPr>
          <p:cNvPr id="93" name="Google Shape;93;p18"/>
          <p:cNvSpPr/>
          <p:nvPr/>
        </p:nvSpPr>
        <p:spPr>
          <a:xfrm>
            <a:off x="6701471" y="2044079"/>
            <a:ext cx="176377" cy="25358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6" name="Google Shape;93;p18">
            <a:extLst>
              <a:ext uri="{FF2B5EF4-FFF2-40B4-BE49-F238E27FC236}">
                <a16:creationId xmlns:a16="http://schemas.microsoft.com/office/drawing/2014/main" id="{B3F8E63B-D36A-120B-7882-5ECCCD562C46}"/>
              </a:ext>
            </a:extLst>
          </p:cNvPr>
          <p:cNvSpPr/>
          <p:nvPr/>
        </p:nvSpPr>
        <p:spPr>
          <a:xfrm>
            <a:off x="7183651" y="2548744"/>
            <a:ext cx="176377" cy="25358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7" name="Google Shape;93;p18">
            <a:extLst>
              <a:ext uri="{FF2B5EF4-FFF2-40B4-BE49-F238E27FC236}">
                <a16:creationId xmlns:a16="http://schemas.microsoft.com/office/drawing/2014/main" id="{D79661CD-9164-432C-C7BA-306F9E52741C}"/>
              </a:ext>
            </a:extLst>
          </p:cNvPr>
          <p:cNvSpPr/>
          <p:nvPr/>
        </p:nvSpPr>
        <p:spPr>
          <a:xfrm>
            <a:off x="6564062" y="3045915"/>
            <a:ext cx="176377" cy="25358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E3E6BF4-9B6F-2FAB-0906-9BACBDEDE65B}"/>
              </a:ext>
            </a:extLst>
          </p:cNvPr>
          <p:cNvSpPr txBox="1"/>
          <p:nvPr/>
        </p:nvSpPr>
        <p:spPr>
          <a:xfrm>
            <a:off x="6586742" y="1711784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gnarl1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Google Shape;120;p22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620" dirty="0"/>
              <a:t>UDP0063__NP_050611.1_in_NC_000929.1_at_4784..5047_desc:hypothetical-protein</a:t>
            </a:r>
            <a:endParaRPr sz="162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620" dirty="0"/>
              <a:t>Mup07</a:t>
            </a:r>
            <a:endParaRPr sz="1620" dirty="0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6D05529A-2FAE-1773-80CC-EA111DAA3B5D}"/>
              </a:ext>
            </a:extLst>
          </p:cNvPr>
          <p:cNvGrpSpPr/>
          <p:nvPr/>
        </p:nvGrpSpPr>
        <p:grpSpPr>
          <a:xfrm>
            <a:off x="334868" y="1260763"/>
            <a:ext cx="8195602" cy="2893017"/>
            <a:chOff x="334868" y="1147355"/>
            <a:chExt cx="8195602" cy="2893017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8108E9BB-E4FD-25CD-310D-1D9D081D2F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31081"/>
            <a:stretch/>
          </p:blipFill>
          <p:spPr>
            <a:xfrm>
              <a:off x="334868" y="1147355"/>
              <a:ext cx="8195602" cy="2503158"/>
            </a:xfrm>
            <a:prstGeom prst="rect">
              <a:avLst/>
            </a:prstGeom>
          </p:spPr>
        </p:pic>
        <p:sp>
          <p:nvSpPr>
            <p:cNvPr id="3" name="Rounded Rectangle 2">
              <a:extLst>
                <a:ext uri="{FF2B5EF4-FFF2-40B4-BE49-F238E27FC236}">
                  <a16:creationId xmlns:a16="http://schemas.microsoft.com/office/drawing/2014/main" id="{15E2B4CC-F09A-BC7B-78D4-E8F8441CB483}"/>
                </a:ext>
              </a:extLst>
            </p:cNvPr>
            <p:cNvSpPr/>
            <p:nvPr/>
          </p:nvSpPr>
          <p:spPr>
            <a:xfrm>
              <a:off x="3012558" y="3168502"/>
              <a:ext cx="4671237" cy="871870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" name="Google Shape;175;p29">
            <a:extLst>
              <a:ext uri="{FF2B5EF4-FFF2-40B4-BE49-F238E27FC236}">
                <a16:creationId xmlns:a16="http://schemas.microsoft.com/office/drawing/2014/main" id="{194E07A6-87D3-B519-BEED-05701D83AA75}"/>
              </a:ext>
            </a:extLst>
          </p:cNvPr>
          <p:cNvSpPr/>
          <p:nvPr/>
        </p:nvSpPr>
        <p:spPr>
          <a:xfrm>
            <a:off x="2751664" y="2147772"/>
            <a:ext cx="191585" cy="326064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1D9DEDD-B0CB-3D9D-46A5-A49EDA33D6A4}"/>
              </a:ext>
            </a:extLst>
          </p:cNvPr>
          <p:cNvSpPr txBox="1"/>
          <p:nvPr/>
        </p:nvSpPr>
        <p:spPr>
          <a:xfrm>
            <a:off x="2556350" y="2473836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gnarl2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phic 2">
            <a:extLst>
              <a:ext uri="{FF2B5EF4-FFF2-40B4-BE49-F238E27FC236}">
                <a16:creationId xmlns:a16="http://schemas.microsoft.com/office/drawing/2014/main" id="{8DFF4C19-770B-30EB-A8A6-5F556A04DA2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 r="6427"/>
          <a:stretch/>
        </p:blipFill>
        <p:spPr>
          <a:xfrm>
            <a:off x="784332" y="1657192"/>
            <a:ext cx="7272867" cy="3240609"/>
          </a:xfrm>
          <a:prstGeom prst="rect">
            <a:avLst/>
          </a:prstGeom>
        </p:spPr>
      </p:pic>
      <p:sp>
        <p:nvSpPr>
          <p:cNvPr id="172" name="Google Shape;172;p29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720" dirty="0"/>
              <a:t>UDP0092__QEG07807.1_in_MN045229.1</a:t>
            </a:r>
            <a:endParaRPr sz="172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720" dirty="0"/>
              <a:t>Escherichia_phage_Mangalitsa_at_4208..4444_desc:hypothetical-protein</a:t>
            </a:r>
            <a:endParaRPr sz="172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720" dirty="0"/>
              <a:t>0.877phamily29972</a:t>
            </a:r>
            <a:endParaRPr sz="1720" dirty="0"/>
          </a:p>
        </p:txBody>
      </p:sp>
      <p:sp>
        <p:nvSpPr>
          <p:cNvPr id="175" name="Google Shape;175;p29"/>
          <p:cNvSpPr/>
          <p:nvPr/>
        </p:nvSpPr>
        <p:spPr>
          <a:xfrm>
            <a:off x="6777068" y="2140034"/>
            <a:ext cx="284700" cy="18660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176" name="Google Shape;176;p29"/>
          <p:cNvSpPr/>
          <p:nvPr/>
        </p:nvSpPr>
        <p:spPr>
          <a:xfrm>
            <a:off x="6500835" y="2594292"/>
            <a:ext cx="284700" cy="18660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177" name="Google Shape;177;p29"/>
          <p:cNvSpPr/>
          <p:nvPr/>
        </p:nvSpPr>
        <p:spPr>
          <a:xfrm>
            <a:off x="6430491" y="3048550"/>
            <a:ext cx="284700" cy="18660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178" name="Google Shape;178;p29"/>
          <p:cNvSpPr/>
          <p:nvPr/>
        </p:nvSpPr>
        <p:spPr>
          <a:xfrm>
            <a:off x="6589775" y="1682376"/>
            <a:ext cx="284700" cy="18660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4" name="Google Shape;177;p29">
            <a:extLst>
              <a:ext uri="{FF2B5EF4-FFF2-40B4-BE49-F238E27FC236}">
                <a16:creationId xmlns:a16="http://schemas.microsoft.com/office/drawing/2014/main" id="{480D336B-796C-3FD5-3BE8-B0F3DE953A6E}"/>
              </a:ext>
            </a:extLst>
          </p:cNvPr>
          <p:cNvSpPr/>
          <p:nvPr/>
        </p:nvSpPr>
        <p:spPr>
          <a:xfrm>
            <a:off x="6527358" y="4414507"/>
            <a:ext cx="284700" cy="18660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A8E8E80-1A39-68CD-263B-6333C521378D}"/>
              </a:ext>
            </a:extLst>
          </p:cNvPr>
          <p:cNvSpPr txBox="1"/>
          <p:nvPr/>
        </p:nvSpPr>
        <p:spPr>
          <a:xfrm>
            <a:off x="6441019" y="1362007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gnarl3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Graphic 11">
            <a:extLst>
              <a:ext uri="{FF2B5EF4-FFF2-40B4-BE49-F238E27FC236}">
                <a16:creationId xmlns:a16="http://schemas.microsoft.com/office/drawing/2014/main" id="{D3EC8ED1-D56A-EEF1-3D03-D4080E9492E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 r="5888"/>
          <a:stretch/>
        </p:blipFill>
        <p:spPr>
          <a:xfrm>
            <a:off x="0" y="1550299"/>
            <a:ext cx="9051403" cy="2952254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BC3C1629-6B81-1066-BA71-61B14B13B9E6}"/>
              </a:ext>
            </a:extLst>
          </p:cNvPr>
          <p:cNvSpPr txBox="1"/>
          <p:nvPr/>
        </p:nvSpPr>
        <p:spPr>
          <a:xfrm>
            <a:off x="480348" y="318399"/>
            <a:ext cx="8189089" cy="8863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720" dirty="0"/>
              <a:t>UDP0116__AXC42625.1_in_MH370387.1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720" dirty="0"/>
              <a:t>Salmonella_phage_S149_at_7439..7155_desc:anti-RecBCD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720" dirty="0"/>
              <a:t>1.019phamily36090</a:t>
            </a:r>
          </a:p>
        </p:txBody>
      </p:sp>
      <p:sp>
        <p:nvSpPr>
          <p:cNvPr id="15" name="Google Shape;178;p29">
            <a:extLst>
              <a:ext uri="{FF2B5EF4-FFF2-40B4-BE49-F238E27FC236}">
                <a16:creationId xmlns:a16="http://schemas.microsoft.com/office/drawing/2014/main" id="{E23842BD-DB3E-10A7-5B20-4BFB84CF5A14}"/>
              </a:ext>
            </a:extLst>
          </p:cNvPr>
          <p:cNvSpPr/>
          <p:nvPr/>
        </p:nvSpPr>
        <p:spPr>
          <a:xfrm>
            <a:off x="6531899" y="1528166"/>
            <a:ext cx="532841" cy="307776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7C9C9BD-7AAC-5E19-0ABF-5200FB231C70}"/>
              </a:ext>
            </a:extLst>
          </p:cNvPr>
          <p:cNvSpPr txBox="1"/>
          <p:nvPr/>
        </p:nvSpPr>
        <p:spPr>
          <a:xfrm>
            <a:off x="6498894" y="1242522"/>
            <a:ext cx="681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abc1</a:t>
            </a:r>
          </a:p>
        </p:txBody>
      </p:sp>
    </p:spTree>
    <p:extLst>
      <p:ext uri="{BB962C8B-B14F-4D97-AF65-F5344CB8AC3E}">
        <p14:creationId xmlns:p14="http://schemas.microsoft.com/office/powerpoint/2010/main" val="5199776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phic 2">
            <a:extLst>
              <a:ext uri="{FF2B5EF4-FFF2-40B4-BE49-F238E27FC236}">
                <a16:creationId xmlns:a16="http://schemas.microsoft.com/office/drawing/2014/main" id="{52FD6CBC-1D6E-23FC-BFBE-12A87A3356E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 r="5229"/>
          <a:stretch/>
        </p:blipFill>
        <p:spPr>
          <a:xfrm>
            <a:off x="905933" y="1371728"/>
            <a:ext cx="6959600" cy="3771772"/>
          </a:xfrm>
          <a:prstGeom prst="rect">
            <a:avLst/>
          </a:prstGeom>
        </p:spPr>
      </p:pic>
      <p:sp>
        <p:nvSpPr>
          <p:cNvPr id="243" name="Google Shape;243;p38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720"/>
              <a:t>UDP0126__VFR14542.1_in_LR535917.1</a:t>
            </a:r>
            <a:endParaRPr sz="172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720"/>
              <a:t>Salmonella_phage_SPFM20_at_22169..22468_desc:hypothetical-protein</a:t>
            </a:r>
            <a:endParaRPr sz="172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720"/>
              <a:t>0.778phamily18902</a:t>
            </a:r>
            <a:endParaRPr sz="1720"/>
          </a:p>
        </p:txBody>
      </p:sp>
      <p:sp>
        <p:nvSpPr>
          <p:cNvPr id="246" name="Google Shape;246;p38"/>
          <p:cNvSpPr/>
          <p:nvPr/>
        </p:nvSpPr>
        <p:spPr>
          <a:xfrm>
            <a:off x="6694666" y="1382727"/>
            <a:ext cx="493500" cy="18660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247" name="Google Shape;247;p38"/>
          <p:cNvSpPr/>
          <p:nvPr/>
        </p:nvSpPr>
        <p:spPr>
          <a:xfrm>
            <a:off x="6694666" y="1749992"/>
            <a:ext cx="493500" cy="186600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B5EE966-E4FE-F3FB-B851-8A227EEBCAD8}"/>
              </a:ext>
            </a:extLst>
          </p:cNvPr>
          <p:cNvSpPr txBox="1"/>
          <p:nvPr/>
        </p:nvSpPr>
        <p:spPr>
          <a:xfrm>
            <a:off x="7062835" y="1111325"/>
            <a:ext cx="6912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orf126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phic 4">
            <a:extLst>
              <a:ext uri="{FF2B5EF4-FFF2-40B4-BE49-F238E27FC236}">
                <a16:creationId xmlns:a16="http://schemas.microsoft.com/office/drawing/2014/main" id="{3F0B4C75-CC91-ED11-501A-EDADC45941D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 r="5338"/>
          <a:stretch/>
        </p:blipFill>
        <p:spPr>
          <a:xfrm>
            <a:off x="884463" y="1524000"/>
            <a:ext cx="6600070" cy="3619500"/>
          </a:xfrm>
          <a:prstGeom prst="rect">
            <a:avLst/>
          </a:prstGeom>
        </p:spPr>
      </p:pic>
      <p:sp>
        <p:nvSpPr>
          <p:cNvPr id="264" name="Google Shape;264;p4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700"/>
              <a:t>UDP0148__ASM62875.1_in_MF402939.1</a:t>
            </a:r>
            <a:endParaRPr sz="170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700"/>
              <a:t>Escherichia_phage_OSYSP_at_6779..6432_desc:hypothetical-protein</a:t>
            </a:r>
            <a:endParaRPr sz="170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1700"/>
              <a:t>1.584phamily12475</a:t>
            </a:r>
            <a:endParaRPr sz="170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endParaRPr sz="170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700"/>
          </a:p>
        </p:txBody>
      </p:sp>
      <p:sp>
        <p:nvSpPr>
          <p:cNvPr id="267" name="Google Shape;267;p41"/>
          <p:cNvSpPr/>
          <p:nvPr/>
        </p:nvSpPr>
        <p:spPr>
          <a:xfrm>
            <a:off x="5561522" y="3569677"/>
            <a:ext cx="610677" cy="206456"/>
          </a:xfrm>
          <a:prstGeom prst="ellipse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540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E378ECA-16E6-CD4B-02B3-9D10581CE4F6}"/>
              </a:ext>
            </a:extLst>
          </p:cNvPr>
          <p:cNvSpPr txBox="1"/>
          <p:nvPr/>
        </p:nvSpPr>
        <p:spPr>
          <a:xfrm>
            <a:off x="4937703" y="3656112"/>
            <a:ext cx="6912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orf148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</TotalTime>
  <Words>172</Words>
  <Application>Microsoft Macintosh PowerPoint</Application>
  <PresentationFormat>On-screen Show (16:9)</PresentationFormat>
  <Paragraphs>30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8" baseType="lpstr">
      <vt:lpstr>Arial</vt:lpstr>
      <vt:lpstr>Simple Light</vt:lpstr>
      <vt:lpstr>UDP0048__ATI16509.1_in_MF663761.1 Klebsiella_phage_vB_KpnM_KpV79_at_36068..35946_desc:hypothetical-protein 0.830phamily36007</vt:lpstr>
      <vt:lpstr>UDP0063__NP_050611.1_in_NC_000929.1_at_4784..5047_desc:hypothetical-protein Mup07</vt:lpstr>
      <vt:lpstr>UDP0092__QEG07807.1_in_MN045229.1 Escherichia_phage_Mangalitsa_at_4208..4444_desc:hypothetical-protein 0.877phamily29972</vt:lpstr>
      <vt:lpstr>PowerPoint Presentation</vt:lpstr>
      <vt:lpstr>UDP0126__VFR14542.1_in_LR535917.1 Salmonella_phage_SPFM20_at_22169..22468_desc:hypothetical-protein 0.778phamily18902</vt:lpstr>
      <vt:lpstr>UDP0148__ASM62875.1_in_MF402939.1 Escherichia_phage_OSYSP_at_6779..6432_desc:hypothetical-protein 1.584phamily12475 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DP0048__ATI16509.1_in_MF663761.1 Klebsiella_phage_vB_KpnM_KpV79_at_36068..35946_desc:hypothetical-protein 0.830phamily36007</dc:title>
  <cp:lastModifiedBy>Sukrit Silas</cp:lastModifiedBy>
  <cp:revision>31</cp:revision>
  <dcterms:modified xsi:type="dcterms:W3CDTF">2024-06-05T01:07:25Z</dcterms:modified>
</cp:coreProperties>
</file>